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76" y="93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0258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974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15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717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7979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610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62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186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9821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041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8363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94FC9-EFAC-44F0-A9D0-7248DC527DB0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898E3-8510-4D4B-BBD8-BDC5D1150D1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055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4624" y="13611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3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299291" y="136110"/>
            <a:ext cx="4440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Effects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MET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inhibition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on human ECs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VSMCs</a:t>
            </a:r>
            <a:endParaRPr lang="de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64002" y="534410"/>
            <a:ext cx="253463" cy="2361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289704" y="526993"/>
            <a:ext cx="314510" cy="2963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15088" y="327279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4149622" y="327279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143625" y="5733256"/>
            <a:ext cx="9489895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ffects of targeting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Cs and VSMC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No effect of targeting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with INC280 on ECs was detected upon constitutive conditions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GF induce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rowth of ECs after 48 and 72 hours of incubation (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). Incubation with INC280 impairs this (*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)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VSMCs, INC280 led to inhibition of constitutive growth upon constitutive conditions (*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)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Upon serum-starved conditions, no effect on constitutive growth was detectable. Similar, stimulation of VSMCs with HGF did not affect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 growth. Bar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E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165" y="898929"/>
            <a:ext cx="3097213" cy="184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9287" y="289998"/>
            <a:ext cx="3962400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343" y="3342553"/>
            <a:ext cx="3011487" cy="2011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9287" y="3185319"/>
            <a:ext cx="3871913" cy="2547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432334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Microsoft Office PowerPoint</Application>
  <PresentationFormat>A4-Papi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 Regens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Arke Lang</dc:creator>
  <cp:lastModifiedBy>Sven Arke Lang</cp:lastModifiedBy>
  <cp:revision>2</cp:revision>
  <dcterms:created xsi:type="dcterms:W3CDTF">2014-07-03T19:53:34Z</dcterms:created>
  <dcterms:modified xsi:type="dcterms:W3CDTF">2014-09-06T13:51:41Z</dcterms:modified>
</cp:coreProperties>
</file>